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43"/>
    <p:restoredTop sz="96543"/>
  </p:normalViewPr>
  <p:slideViewPr>
    <p:cSldViewPr snapToGrid="0" snapToObjects="1">
      <p:cViewPr varScale="1">
        <p:scale>
          <a:sx n="112" d="100"/>
          <a:sy n="112" d="100"/>
        </p:scale>
        <p:origin x="27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033053-24B6-CB48-A926-E982A458AE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07D309-DEB6-384A-BE5E-F22BE51DE9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23E5D7-5DA6-EC46-93BB-46F3C5CD0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F8928F-7CD8-754C-9BF2-29DB66EA0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138A3D-5885-AF4B-8200-6BE8D2F0B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39487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8D231A-5940-2049-BF35-D81E86B29C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BD4EC6-9114-BC46-96DB-BB452E29B2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03403C-2DE9-5E42-A16A-04427A325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EB76AD-0EDA-374E-9D89-54181C9B0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6DC11A-162E-7748-A83C-9076B4564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5028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C96189-82FB-0540-9DC1-9B49FE4086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120CBA-E513-B747-BEDE-726C896CD0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884AF3-BBED-124E-961D-1821A0F06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C36E4B-410E-C741-B70D-29B13D0E3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4EEE4C-1E62-0B4E-BC61-ACF1C8C8F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1559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333BB5-88B8-194D-B83A-13024B4A32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C87293-40B1-DB42-97A2-2842B5C58B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356702-8203-CB42-ABE6-5688449FF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A4C1E1-9967-C340-AA61-756CB4E2C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DC37E3-C73C-624E-9011-8DD141BBF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3990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E9F84-4566-6D4D-885E-5AB83B1D30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F25B5B-5D7C-9A40-9099-25E67369B0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59F97A-CB93-A24E-9E9A-2D0EE3B14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A6AECD-CC71-3B40-9372-D7A095369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8C02EB-C9D1-0941-9F32-80BB39E88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9997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7E21F4-9F6E-074F-B8E2-BB7E321C8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AEB520-4BBA-E543-9C63-63B0FEA969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F806E4-6F96-0344-8E68-7BC5760013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82CA49-66B1-B443-92B1-2C78CC9A4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09881F-069E-B54C-B05F-20119A8AC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E100FD-0F5B-EA4B-9679-B23AA3948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647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F6679-2FBE-0845-808E-27B2EC43CD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3F6310-7A84-BA40-8DCE-043559206D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FEEDD2-1CEF-364B-8F9B-29A8394E1F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0A8C96-523B-CD42-AB2F-4B80B62F02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300E1A4-ECF6-7B45-910A-99E59E22E1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923B923-0294-DD46-8B23-EC4136B411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65044D-0F6D-F541-930A-88CC1B13A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420ECF4-CDF7-EF4A-BC50-4D9D1BBC0F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2977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A8EAD0-2D55-DC41-8AB4-0AECF79F3B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61F5EE-99CB-4544-8DC5-0F84C52CD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C8A8B96-F98F-B745-BF6A-EB80304FB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E471A40-74D0-7342-BC6F-5974B8F0C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871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89A2800-9BE9-8C44-BC19-A1CA3080F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D047654-F152-754C-996F-9E9F15411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05A63CF-2E77-3540-B873-443B5C08E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6532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A6AC22-8533-AA48-8E3D-FD7301D341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2D4DBC-54BE-CD46-AD05-3FB469A811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85DCE8-06AB-FE44-894D-7004B78F7F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1B7841-FAB9-FB49-BECF-8091F9C46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099745-6B9C-994C-B08F-3CF317A9CB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ACF93B-14F8-CC4C-86A6-283B191C4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166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0ABFB-1852-DE45-9C15-D3DC868060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18C6A1-5B1F-F646-B644-C1624A91BD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DBCE43-41C7-B946-8000-862E333F6E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2B652E-5041-BD44-A1EB-64C7E1C98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9C07CC-DBC3-3347-868B-217135456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8D70A9-30C8-0D42-B0AC-32C807A407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0886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ECFA0B-4C87-BB46-A24E-4E78BA6EA5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2F0B09-8DD7-0A46-BFC0-FB52B991E7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781224-D9C5-8744-8C29-FA75942241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2715E4-FECC-3341-921D-745F988F0A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2E07E2-14E0-5C42-9506-AFEC3BF94E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4939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D0081856-3613-466C-BA8A-8017FBA4D57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4852" y="1212980"/>
            <a:ext cx="5372356" cy="404754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48E9AA9-34CF-44FE-AD27-43F0785F394D}"/>
              </a:ext>
            </a:extLst>
          </p:cNvPr>
          <p:cNvSpPr/>
          <p:nvPr/>
        </p:nvSpPr>
        <p:spPr>
          <a:xfrm>
            <a:off x="9891702" y="6361607"/>
            <a:ext cx="21621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Supplementary Fig. 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BED4BA4-CA4E-4979-9016-F2EED91162D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322666" y="1212980"/>
            <a:ext cx="5332873" cy="404754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3D7959C-3324-4349-B64C-D722F9B90A0B}"/>
              </a:ext>
            </a:extLst>
          </p:cNvPr>
          <p:cNvSpPr txBox="1"/>
          <p:nvPr/>
        </p:nvSpPr>
        <p:spPr>
          <a:xfrm>
            <a:off x="361372" y="862569"/>
            <a:ext cx="3501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GB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2250525-B105-4B67-B9D3-80DB5780364A}"/>
              </a:ext>
            </a:extLst>
          </p:cNvPr>
          <p:cNvSpPr txBox="1"/>
          <p:nvPr/>
        </p:nvSpPr>
        <p:spPr>
          <a:xfrm>
            <a:off x="6096000" y="862569"/>
            <a:ext cx="3501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GB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C1667EF-3D45-7440-BFAE-276C5AF37859}"/>
              </a:ext>
            </a:extLst>
          </p:cNvPr>
          <p:cNvSpPr txBox="1"/>
          <p:nvPr/>
        </p:nvSpPr>
        <p:spPr>
          <a:xfrm>
            <a:off x="842470" y="919554"/>
            <a:ext cx="5070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Cross-reference soil and ambient temperature sensor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5DDA3F1-38A9-A94F-91F2-ED1EDDEDAA2A}"/>
              </a:ext>
            </a:extLst>
          </p:cNvPr>
          <p:cNvSpPr txBox="1"/>
          <p:nvPr/>
        </p:nvSpPr>
        <p:spPr>
          <a:xfrm>
            <a:off x="6550090" y="919554"/>
            <a:ext cx="51054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Compare infield sensors and a nearby weather stati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15B365C-2157-5D46-808C-96513A534776}"/>
              </a:ext>
            </a:extLst>
          </p:cNvPr>
          <p:cNvSpPr txBox="1"/>
          <p:nvPr/>
        </p:nvSpPr>
        <p:spPr>
          <a:xfrm>
            <a:off x="842469" y="5140745"/>
            <a:ext cx="5070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/>
              <a:t>Growing seas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3CD2D10-1ED1-AE43-9695-E09CCBE704B9}"/>
              </a:ext>
            </a:extLst>
          </p:cNvPr>
          <p:cNvSpPr txBox="1"/>
          <p:nvPr/>
        </p:nvSpPr>
        <p:spPr>
          <a:xfrm rot="16200000">
            <a:off x="-1366178" y="3019152"/>
            <a:ext cx="37617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/>
              <a:t>Relative value (0.0-1.0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9830363-2BB3-0A40-9CA6-3409C73DB5F8}"/>
              </a:ext>
            </a:extLst>
          </p:cNvPr>
          <p:cNvSpPr txBox="1"/>
          <p:nvPr/>
        </p:nvSpPr>
        <p:spPr>
          <a:xfrm rot="16200000">
            <a:off x="4371269" y="3000491"/>
            <a:ext cx="37617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/>
              <a:t>Relative humidity (0-100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8B4C021-D9D7-5C43-858C-ACE718C691CB}"/>
              </a:ext>
            </a:extLst>
          </p:cNvPr>
          <p:cNvSpPr txBox="1"/>
          <p:nvPr/>
        </p:nvSpPr>
        <p:spPr>
          <a:xfrm>
            <a:off x="6584738" y="5140745"/>
            <a:ext cx="5070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/>
              <a:t>Growing season</a:t>
            </a:r>
          </a:p>
        </p:txBody>
      </p:sp>
    </p:spTree>
    <p:extLst>
      <p:ext uri="{BB962C8B-B14F-4D97-AF65-F5344CB8AC3E}">
        <p14:creationId xmlns:p14="http://schemas.microsoft.com/office/powerpoint/2010/main" val="1414668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99</TotalTime>
  <Words>34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 Zhou (TGAC)</dc:creator>
  <cp:lastModifiedBy>Daniel Reynolds (EI)</cp:lastModifiedBy>
  <cp:revision>67</cp:revision>
  <dcterms:created xsi:type="dcterms:W3CDTF">2018-09-30T13:29:54Z</dcterms:created>
  <dcterms:modified xsi:type="dcterms:W3CDTF">2018-12-18T16:47:26Z</dcterms:modified>
</cp:coreProperties>
</file>